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5" d="100"/>
          <a:sy n="125" d="100"/>
        </p:scale>
        <p:origin x="-2054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D3287-C407-496E-8733-631CF16394A0}" type="datetimeFigureOut">
              <a:rPr lang="en-GB" smtClean="0"/>
              <a:t>2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9592-D10A-4E88-B890-4E4EB2DCD8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8848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D3287-C407-496E-8733-631CF16394A0}" type="datetimeFigureOut">
              <a:rPr lang="en-GB" smtClean="0"/>
              <a:t>2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9592-D10A-4E88-B890-4E4EB2DCD8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9627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D3287-C407-496E-8733-631CF16394A0}" type="datetimeFigureOut">
              <a:rPr lang="en-GB" smtClean="0"/>
              <a:t>2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9592-D10A-4E88-B890-4E4EB2DCD8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53736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D3287-C407-496E-8733-631CF16394A0}" type="datetimeFigureOut">
              <a:rPr lang="en-GB" smtClean="0"/>
              <a:t>2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9592-D10A-4E88-B890-4E4EB2DCD8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9871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D3287-C407-496E-8733-631CF16394A0}" type="datetimeFigureOut">
              <a:rPr lang="en-GB" smtClean="0"/>
              <a:t>2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9592-D10A-4E88-B890-4E4EB2DCD8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57737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D3287-C407-496E-8733-631CF16394A0}" type="datetimeFigureOut">
              <a:rPr lang="en-GB" smtClean="0"/>
              <a:t>25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9592-D10A-4E88-B890-4E4EB2DCD8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0565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D3287-C407-496E-8733-631CF16394A0}" type="datetimeFigureOut">
              <a:rPr lang="en-GB" smtClean="0"/>
              <a:t>25/12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9592-D10A-4E88-B890-4E4EB2DCD8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8522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D3287-C407-496E-8733-631CF16394A0}" type="datetimeFigureOut">
              <a:rPr lang="en-GB" smtClean="0"/>
              <a:t>25/1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9592-D10A-4E88-B890-4E4EB2DCD8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29216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D3287-C407-496E-8733-631CF16394A0}" type="datetimeFigureOut">
              <a:rPr lang="en-GB" smtClean="0"/>
              <a:t>25/12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9592-D10A-4E88-B890-4E4EB2DCD8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66600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D3287-C407-496E-8733-631CF16394A0}" type="datetimeFigureOut">
              <a:rPr lang="en-GB" smtClean="0"/>
              <a:t>25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9592-D10A-4E88-B890-4E4EB2DCD8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8622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D3287-C407-496E-8733-631CF16394A0}" type="datetimeFigureOut">
              <a:rPr lang="en-GB" smtClean="0"/>
              <a:t>25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9592-D10A-4E88-B890-4E4EB2DCD8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7230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D3287-C407-496E-8733-631CF16394A0}" type="datetimeFigureOut">
              <a:rPr lang="en-GB" smtClean="0"/>
              <a:t>2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439592-D10A-4E88-B890-4E4EB2DCD8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7437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5C31251-0441-4552-BCD7-E2618ABFA1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0153" y="2905760"/>
            <a:ext cx="10797469" cy="6482080"/>
          </a:xfrm>
          <a:prstGeom prst="rect">
            <a:avLst/>
          </a:prstGeom>
        </p:spPr>
      </p:pic>
      <p:sp>
        <p:nvSpPr>
          <p:cNvPr id="5" name="Arrow: Right 4">
            <a:extLst>
              <a:ext uri="{FF2B5EF4-FFF2-40B4-BE49-F238E27FC236}">
                <a16:creationId xmlns:a16="http://schemas.microsoft.com/office/drawing/2014/main" id="{39E45125-5185-4CD2-8488-1A51F76C58BF}"/>
              </a:ext>
            </a:extLst>
          </p:cNvPr>
          <p:cNvSpPr/>
          <p:nvPr/>
        </p:nvSpPr>
        <p:spPr>
          <a:xfrm rot="20461037">
            <a:off x="2554515" y="6691085"/>
            <a:ext cx="978408" cy="383032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758F4389-FE42-4379-A620-203A905CC272}"/>
              </a:ext>
            </a:extLst>
          </p:cNvPr>
          <p:cNvSpPr/>
          <p:nvPr/>
        </p:nvSpPr>
        <p:spPr>
          <a:xfrm rot="20461037">
            <a:off x="3079411" y="7433359"/>
            <a:ext cx="978408" cy="383032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2893527D-D2EF-4F39-A45F-CB5B1C45D8D6}"/>
              </a:ext>
            </a:extLst>
          </p:cNvPr>
          <p:cNvSpPr/>
          <p:nvPr/>
        </p:nvSpPr>
        <p:spPr>
          <a:xfrm rot="20461037">
            <a:off x="3797868" y="7966029"/>
            <a:ext cx="978408" cy="383032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Arrow: Right 7">
            <a:extLst>
              <a:ext uri="{FF2B5EF4-FFF2-40B4-BE49-F238E27FC236}">
                <a16:creationId xmlns:a16="http://schemas.microsoft.com/office/drawing/2014/main" id="{BF867A12-4301-4A9D-900B-472B6DD331FD}"/>
              </a:ext>
            </a:extLst>
          </p:cNvPr>
          <p:cNvSpPr/>
          <p:nvPr/>
        </p:nvSpPr>
        <p:spPr>
          <a:xfrm rot="7717784">
            <a:off x="6954725" y="2954067"/>
            <a:ext cx="978408" cy="383032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525DB05-AC8C-4771-8B8C-DA5BF3A3B0E3}"/>
              </a:ext>
            </a:extLst>
          </p:cNvPr>
          <p:cNvSpPr txBox="1"/>
          <p:nvPr/>
        </p:nvSpPr>
        <p:spPr>
          <a:xfrm>
            <a:off x="1121561" y="9920510"/>
            <a:ext cx="99488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dar plot depicting rating of 16 different statements specific to Question 11 from the survey  </a:t>
            </a:r>
          </a:p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ed to physical, social and emotional well being from the perspective of dermatologists and patients.</a:t>
            </a:r>
          </a:p>
        </p:txBody>
      </p:sp>
      <p:sp>
        <p:nvSpPr>
          <p:cNvPr id="10" name="TextBox 8">
            <a:extLst>
              <a:ext uri="{FF2B5EF4-FFF2-40B4-BE49-F238E27FC236}">
                <a16:creationId xmlns:a16="http://schemas.microsoft.com/office/drawing/2014/main" id="{5D918A45-20D5-4C8C-80AA-B53DE9239E17}"/>
              </a:ext>
            </a:extLst>
          </p:cNvPr>
          <p:cNvSpPr txBox="1"/>
          <p:nvPr/>
        </p:nvSpPr>
        <p:spPr>
          <a:xfrm>
            <a:off x="10125596" y="323334"/>
            <a:ext cx="18896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/>
              <a:t>Supplementary S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78740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34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lin Gerard Egan</dc:creator>
  <cp:lastModifiedBy>MDPI</cp:lastModifiedBy>
  <cp:revision>7</cp:revision>
  <cp:lastPrinted>2023-12-23T23:41:07Z</cp:lastPrinted>
  <dcterms:created xsi:type="dcterms:W3CDTF">2023-10-16T10:06:48Z</dcterms:created>
  <dcterms:modified xsi:type="dcterms:W3CDTF">2023-12-25T01:26:54Z</dcterms:modified>
</cp:coreProperties>
</file>